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0" r:id="rId2"/>
    <p:sldId id="312" r:id="rId3"/>
    <p:sldId id="313" r:id="rId4"/>
    <p:sldId id="304" r:id="rId5"/>
    <p:sldId id="314" r:id="rId6"/>
    <p:sldId id="294" r:id="rId7"/>
    <p:sldId id="301" r:id="rId8"/>
    <p:sldId id="302" r:id="rId9"/>
    <p:sldId id="303" r:id="rId10"/>
    <p:sldId id="315" r:id="rId11"/>
    <p:sldId id="316" r:id="rId1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3" d="100"/>
          <a:sy n="43" d="100"/>
        </p:scale>
        <p:origin x="20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288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103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363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922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68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906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420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55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836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638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504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854AF-A74A-4803-A02A-CD2099C15484}" type="datetimeFigureOut">
              <a:rPr lang="en-US" smtClean="0"/>
              <a:t>7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BED5A-010E-4DA0-860B-C4AC4969B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802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4.bin"/><Relationship Id="rId9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13" Type="http://schemas.openxmlformats.org/officeDocument/2006/relationships/image" Target="../media/image16.emf"/><Relationship Id="rId18" Type="http://schemas.openxmlformats.org/officeDocument/2006/relationships/oleObject" Target="../embeddings/oleObject15.bin"/><Relationship Id="rId26" Type="http://schemas.openxmlformats.org/officeDocument/2006/relationships/oleObject" Target="../embeddings/oleObject19.bin"/><Relationship Id="rId3" Type="http://schemas.openxmlformats.org/officeDocument/2006/relationships/image" Target="../media/image11.emf"/><Relationship Id="rId21" Type="http://schemas.openxmlformats.org/officeDocument/2006/relationships/image" Target="../media/image20.emf"/><Relationship Id="rId7" Type="http://schemas.openxmlformats.org/officeDocument/2006/relationships/image" Target="../media/image13.emf"/><Relationship Id="rId12" Type="http://schemas.openxmlformats.org/officeDocument/2006/relationships/oleObject" Target="../embeddings/oleObject12.bin"/><Relationship Id="rId17" Type="http://schemas.openxmlformats.org/officeDocument/2006/relationships/image" Target="../media/image18.emf"/><Relationship Id="rId25" Type="http://schemas.openxmlformats.org/officeDocument/2006/relationships/image" Target="../media/image22.emf"/><Relationship Id="rId2" Type="http://schemas.openxmlformats.org/officeDocument/2006/relationships/oleObject" Target="../embeddings/oleObject7.bin"/><Relationship Id="rId16" Type="http://schemas.openxmlformats.org/officeDocument/2006/relationships/oleObject" Target="../embeddings/oleObject14.bin"/><Relationship Id="rId20" Type="http://schemas.openxmlformats.org/officeDocument/2006/relationships/oleObject" Target="../embeddings/oleObject16.bin"/><Relationship Id="rId1" Type="http://schemas.openxmlformats.org/officeDocument/2006/relationships/slideLayout" Target="../slideLayouts/slideLayout6.xml"/><Relationship Id="rId6" Type="http://schemas.openxmlformats.org/officeDocument/2006/relationships/oleObject" Target="../embeddings/oleObject9.bin"/><Relationship Id="rId11" Type="http://schemas.openxmlformats.org/officeDocument/2006/relationships/image" Target="../media/image15.emf"/><Relationship Id="rId24" Type="http://schemas.openxmlformats.org/officeDocument/2006/relationships/oleObject" Target="../embeddings/oleObject18.bin"/><Relationship Id="rId5" Type="http://schemas.openxmlformats.org/officeDocument/2006/relationships/image" Target="../media/image12.emf"/><Relationship Id="rId15" Type="http://schemas.openxmlformats.org/officeDocument/2006/relationships/image" Target="../media/image17.emf"/><Relationship Id="rId23" Type="http://schemas.openxmlformats.org/officeDocument/2006/relationships/image" Target="../media/image21.emf"/><Relationship Id="rId10" Type="http://schemas.openxmlformats.org/officeDocument/2006/relationships/oleObject" Target="../embeddings/oleObject11.bin"/><Relationship Id="rId19" Type="http://schemas.openxmlformats.org/officeDocument/2006/relationships/image" Target="../media/image19.emf"/><Relationship Id="rId4" Type="http://schemas.openxmlformats.org/officeDocument/2006/relationships/oleObject" Target="../embeddings/oleObject8.bin"/><Relationship Id="rId9" Type="http://schemas.openxmlformats.org/officeDocument/2006/relationships/image" Target="../media/image14.emf"/><Relationship Id="rId14" Type="http://schemas.openxmlformats.org/officeDocument/2006/relationships/oleObject" Target="../embeddings/oleObject13.bin"/><Relationship Id="rId22" Type="http://schemas.openxmlformats.org/officeDocument/2006/relationships/oleObject" Target="../embeddings/oleObject17.bin"/><Relationship Id="rId27" Type="http://schemas.openxmlformats.org/officeDocument/2006/relationships/image" Target="../media/image23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6E5C369-1E6F-76F3-109C-F019B7EB13B1}"/>
              </a:ext>
            </a:extLst>
          </p:cNvPr>
          <p:cNvGrpSpPr/>
          <p:nvPr/>
        </p:nvGrpSpPr>
        <p:grpSpPr>
          <a:xfrm>
            <a:off x="2895779" y="4280442"/>
            <a:ext cx="1350145" cy="2007762"/>
            <a:chOff x="757299" y="2095105"/>
            <a:chExt cx="2117875" cy="3149431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DCEAFA6A-E1AF-1D81-A968-609C67876821}"/>
                </a:ext>
              </a:extLst>
            </p:cNvPr>
            <p:cNvGrpSpPr/>
            <p:nvPr/>
          </p:nvGrpSpPr>
          <p:grpSpPr>
            <a:xfrm>
              <a:off x="757299" y="2095105"/>
              <a:ext cx="2073380" cy="2667789"/>
              <a:chOff x="653604" y="3825087"/>
              <a:chExt cx="2073380" cy="2667789"/>
            </a:xfrm>
          </p:grpSpPr>
          <p:pic>
            <p:nvPicPr>
              <p:cNvPr id="6" name="Picture 5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F16C9A1F-CD1F-5E31-B8F5-B509B23E2D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245" t="29779" r="41856" b="52260"/>
              <a:stretch/>
            </p:blipFill>
            <p:spPr>
              <a:xfrm rot="5400000">
                <a:off x="931177" y="4697068"/>
                <a:ext cx="2667788" cy="923827"/>
              </a:xfrm>
              <a:prstGeom prst="rect">
                <a:avLst/>
              </a:prstGeom>
              <a:solidFill>
                <a:srgbClr val="FFFFFF">
                  <a:shade val="85000"/>
                </a:srgbClr>
              </a:solidFill>
              <a:ln w="88900" cap="sq">
                <a:solidFill>
                  <a:schemeClr val="tx1"/>
                </a:solidFill>
                <a:miter lim="800000"/>
              </a:ln>
              <a:effectLst>
                <a:outerShdw blurRad="55000" dist="18000" dir="54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twoPt" dir="t">
                  <a:rot lat="0" lon="0" rev="7200000"/>
                </a:lightRig>
              </a:scene3d>
              <a:sp3d>
                <a:bevelT w="25400" h="19050"/>
                <a:contourClr>
                  <a:srgbClr val="FFFFFF"/>
                </a:contourClr>
              </a:sp3d>
            </p:spPr>
          </p:pic>
          <p:pic>
            <p:nvPicPr>
              <p:cNvPr id="7" name="Picture 6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049659B5-524B-63AB-5740-25ABC7F2DE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141" t="22186" r="31959" b="57253"/>
              <a:stretch/>
            </p:blipFill>
            <p:spPr>
              <a:xfrm rot="5400000">
                <a:off x="-151515" y="4630206"/>
                <a:ext cx="2667787" cy="1057550"/>
              </a:xfrm>
              <a:prstGeom prst="rect">
                <a:avLst/>
              </a:prstGeom>
              <a:solidFill>
                <a:srgbClr val="FFFFFF">
                  <a:shade val="85000"/>
                </a:srgbClr>
              </a:solidFill>
              <a:ln w="88900" cap="sq">
                <a:solidFill>
                  <a:schemeClr val="tx1"/>
                </a:solidFill>
                <a:miter lim="800000"/>
              </a:ln>
              <a:effectLst>
                <a:outerShdw blurRad="55000" dist="18000" dir="54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twoPt" dir="t">
                  <a:rot lat="0" lon="0" rev="7200000"/>
                </a:lightRig>
              </a:scene3d>
              <a:sp3d>
                <a:bevelT w="25400" h="19050"/>
                <a:contourClr>
                  <a:srgbClr val="FFFFFF"/>
                </a:contourClr>
              </a:sp3d>
            </p:spPr>
          </p:pic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90AEBA8-B110-C9A1-04BE-7186057E9CF1}"/>
                </a:ext>
              </a:extLst>
            </p:cNvPr>
            <p:cNvSpPr txBox="1"/>
            <p:nvPr/>
          </p:nvSpPr>
          <p:spPr>
            <a:xfrm>
              <a:off x="781638" y="4810028"/>
              <a:ext cx="2093536" cy="434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      DSS 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118E351F-7F94-F750-13DD-6FC613DBB693}"/>
              </a:ext>
            </a:extLst>
          </p:cNvPr>
          <p:cNvSpPr txBox="1"/>
          <p:nvPr/>
        </p:nvSpPr>
        <p:spPr>
          <a:xfrm>
            <a:off x="0" y="6462940"/>
            <a:ext cx="7772400" cy="11209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Representative images of decreased colon lengths </a:t>
            </a:r>
            <a:r>
              <a:rPr lang="en-US" sz="1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of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ol and DSS treated mice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5031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22DFA05-0770-EAE8-EEED-54273A6049D1}"/>
              </a:ext>
            </a:extLst>
          </p:cNvPr>
          <p:cNvSpPr txBox="1"/>
          <p:nvPr/>
        </p:nvSpPr>
        <p:spPr>
          <a:xfrm>
            <a:off x="0" y="7800961"/>
            <a:ext cx="7772400" cy="11209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1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able summarizing notable changes in gut microbiota determined by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linear discriminant analysis effect size (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LEfS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.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273C9F0-09F9-5794-6F02-4BAF3E19C7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092133"/>
              </p:ext>
            </p:extLst>
          </p:nvPr>
        </p:nvGraphicFramePr>
        <p:xfrm>
          <a:off x="932390" y="1091380"/>
          <a:ext cx="5907619" cy="6361264"/>
        </p:xfrm>
        <a:graphic>
          <a:graphicData uri="http://schemas.openxmlformats.org/drawingml/2006/table">
            <a:tbl>
              <a:tblPr/>
              <a:tblGrid>
                <a:gridCol w="2968627">
                  <a:extLst>
                    <a:ext uri="{9D8B030D-6E8A-4147-A177-3AD203B41FA5}">
                      <a16:colId xmlns:a16="http://schemas.microsoft.com/office/drawing/2014/main" val="3170536800"/>
                    </a:ext>
                  </a:extLst>
                </a:gridCol>
                <a:gridCol w="1182688">
                  <a:extLst>
                    <a:ext uri="{9D8B030D-6E8A-4147-A177-3AD203B41FA5}">
                      <a16:colId xmlns:a16="http://schemas.microsoft.com/office/drawing/2014/main" val="3415238768"/>
                    </a:ext>
                  </a:extLst>
                </a:gridCol>
                <a:gridCol w="766762">
                  <a:extLst>
                    <a:ext uri="{9D8B030D-6E8A-4147-A177-3AD203B41FA5}">
                      <a16:colId xmlns:a16="http://schemas.microsoft.com/office/drawing/2014/main" val="4047300394"/>
                    </a:ext>
                  </a:extLst>
                </a:gridCol>
                <a:gridCol w="989542">
                  <a:extLst>
                    <a:ext uri="{9D8B030D-6E8A-4147-A177-3AD203B41FA5}">
                      <a16:colId xmlns:a16="http://schemas.microsoft.com/office/drawing/2014/main" val="2962776783"/>
                    </a:ext>
                  </a:extLst>
                </a:gridCol>
              </a:tblGrid>
              <a:tr h="2446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Taxa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Treatment Group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LDA Scor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7123374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 Bacilli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8844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73321321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 Bacteroidia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44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1623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17435544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 Betaproteobacteria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3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7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4211759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 Erysipelotrichia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2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2377439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 Gammaproteobacteria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0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513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12849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 Verrucomicrobi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57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7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57894690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der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cteroidal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44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1623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22962016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der Burkholderiales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3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7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27204474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der Erysipelotrichales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2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35794482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der Lactobacillales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8844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82623997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der Pseudomonadales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0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513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3096576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der Verrucomicrobiales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57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7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7435340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Alcaligen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3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7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71918952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Clostridi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3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161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6977037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rysipelotrichace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2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02767547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Lactobacill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8844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22610537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Moraxell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0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513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48411249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Peptostreptococc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06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9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31374268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Streptococc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5413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23686722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Verrucomicrobi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57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7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00916803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 Clostridia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6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7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51599020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der Clostridiales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6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7E-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93195289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der Desulfovibrionales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5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7702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31172474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Desulfovibrion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4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7702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3140390"/>
                  </a:ext>
                </a:extLst>
              </a:tr>
              <a:tr h="244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Prevotellaceae</a:t>
                      </a: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88</a:t>
                      </a:r>
                    </a:p>
                  </a:txBody>
                  <a:tcPr marL="6350" marR="952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0481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28385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668889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395B06E-7C07-10EF-1A18-EF60054DFE0B}"/>
              </a:ext>
            </a:extLst>
          </p:cNvPr>
          <p:cNvSpPr txBox="1"/>
          <p:nvPr/>
        </p:nvSpPr>
        <p:spPr>
          <a:xfrm>
            <a:off x="0" y="7800961"/>
            <a:ext cx="7772400" cy="22224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2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able summarizing notable overlapping changes in gut microbiota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tween this study and previous human inflammatory bowel disease (IBD) studies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 determined by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linear discriminant analysis effect size (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LEfS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.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38EC36A-E57A-7F10-C2EE-493057EECB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836101"/>
              </p:ext>
            </p:extLst>
          </p:nvPr>
        </p:nvGraphicFramePr>
        <p:xfrm>
          <a:off x="125753" y="3570070"/>
          <a:ext cx="7516369" cy="2029601"/>
        </p:xfrm>
        <a:graphic>
          <a:graphicData uri="http://schemas.openxmlformats.org/drawingml/2006/table">
            <a:tbl>
              <a:tblPr/>
              <a:tblGrid>
                <a:gridCol w="2105489">
                  <a:extLst>
                    <a:ext uri="{9D8B030D-6E8A-4147-A177-3AD203B41FA5}">
                      <a16:colId xmlns:a16="http://schemas.microsoft.com/office/drawing/2014/main" val="937212151"/>
                    </a:ext>
                  </a:extLst>
                </a:gridCol>
                <a:gridCol w="1052744">
                  <a:extLst>
                    <a:ext uri="{9D8B030D-6E8A-4147-A177-3AD203B41FA5}">
                      <a16:colId xmlns:a16="http://schemas.microsoft.com/office/drawing/2014/main" val="1491245920"/>
                    </a:ext>
                  </a:extLst>
                </a:gridCol>
                <a:gridCol w="747109">
                  <a:extLst>
                    <a:ext uri="{9D8B030D-6E8A-4147-A177-3AD203B41FA5}">
                      <a16:colId xmlns:a16="http://schemas.microsoft.com/office/drawing/2014/main" val="829491232"/>
                    </a:ext>
                  </a:extLst>
                </a:gridCol>
                <a:gridCol w="693305">
                  <a:extLst>
                    <a:ext uri="{9D8B030D-6E8A-4147-A177-3AD203B41FA5}">
                      <a16:colId xmlns:a16="http://schemas.microsoft.com/office/drawing/2014/main" val="237231729"/>
                    </a:ext>
                  </a:extLst>
                </a:gridCol>
                <a:gridCol w="2917722">
                  <a:extLst>
                    <a:ext uri="{9D8B030D-6E8A-4147-A177-3AD203B41FA5}">
                      <a16:colId xmlns:a16="http://schemas.microsoft.com/office/drawing/2014/main" val="955727400"/>
                    </a:ext>
                  </a:extLst>
                </a:gridCol>
              </a:tblGrid>
              <a:tr h="19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Taxa</a:t>
                      </a:r>
                    </a:p>
                  </a:txBody>
                  <a:tcPr marL="5047" marR="5047" marT="5047" marB="0" anchor="b">
                    <a:lnL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Treatment Group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LDA Score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Changes in Inflammatory Bowel Disease (IBD)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9608126"/>
                  </a:ext>
                </a:extLst>
              </a:tr>
              <a:tr h="1943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us Erysipelatoclostridium</a:t>
                      </a:r>
                    </a:p>
                  </a:txBody>
                  <a:tcPr marL="5047" marR="5047" marT="5047" marB="0" anchor="b">
                    <a:lnL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4</a:t>
                      </a:r>
                    </a:p>
                  </a:txBody>
                  <a:tcPr marL="5047" marR="45423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9E-05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reased in Crohn's Disease [36]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0978317"/>
                  </a:ext>
                </a:extLst>
              </a:tr>
              <a:tr h="1943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us Lactobacillus</a:t>
                      </a:r>
                    </a:p>
                  </a:txBody>
                  <a:tcPr marL="5047" marR="5047" marT="5047" marB="0" anchor="b">
                    <a:lnL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5</a:t>
                      </a:r>
                    </a:p>
                  </a:txBody>
                  <a:tcPr marL="5047" marR="45423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884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reased in Crohn's Disease [37]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2530510"/>
                  </a:ext>
                </a:extLst>
              </a:tr>
              <a:tr h="35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ecies: Acinetobacter calcoaceticus pittii</a:t>
                      </a:r>
                    </a:p>
                  </a:txBody>
                  <a:tcPr marL="5047" marR="5047" marT="5047" marB="0" anchor="b">
                    <a:lnL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6</a:t>
                      </a:r>
                    </a:p>
                  </a:txBody>
                  <a:tcPr marL="5047" marR="45423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541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reased in Ulcerative Colitis [38]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2785628"/>
                  </a:ext>
                </a:extLst>
              </a:tr>
              <a:tr h="1943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ecies: Turicibacter sanguinis</a:t>
                      </a:r>
                    </a:p>
                  </a:txBody>
                  <a:tcPr marL="5047" marR="5047" marT="5047" marB="0" anchor="b">
                    <a:lnL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S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53</a:t>
                      </a:r>
                    </a:p>
                  </a:txBody>
                  <a:tcPr marL="5047" marR="45423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6E-05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reased in Crohn's Disease [39]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35893"/>
                  </a:ext>
                </a:extLst>
              </a:tr>
              <a:tr h="35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 Deltaproteobacteria</a:t>
                      </a:r>
                    </a:p>
                  </a:txBody>
                  <a:tcPr marL="5047" marR="5047" marT="5047" marB="0" anchor="b">
                    <a:lnL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2</a:t>
                      </a:r>
                    </a:p>
                  </a:txBody>
                  <a:tcPr marL="5047" marR="45423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77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reased in Ulcerative Colitis and Crohn's Disease [40]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99474"/>
                  </a:ext>
                </a:extLst>
              </a:tr>
              <a:tr h="1943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Lachnospiraceae</a:t>
                      </a:r>
                    </a:p>
                  </a:txBody>
                  <a:tcPr marL="5047" marR="5047" marT="5047" marB="0" anchor="b">
                    <a:lnL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2</a:t>
                      </a:r>
                    </a:p>
                  </a:txBody>
                  <a:tcPr marL="5047" marR="45423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7E-05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reased in IBD [41]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2402789"/>
                  </a:ext>
                </a:extLst>
              </a:tr>
              <a:tr h="1943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Ruminococcaceae</a:t>
                      </a:r>
                    </a:p>
                  </a:txBody>
                  <a:tcPr marL="5047" marR="5047" marT="5047" marB="0" anchor="b">
                    <a:lnL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35</a:t>
                      </a:r>
                    </a:p>
                  </a:txBody>
                  <a:tcPr marL="5047" marR="45423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37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reased in IBD [42]</a:t>
                      </a:r>
                    </a:p>
                  </a:txBody>
                  <a:tcPr marL="5047" marR="5047" marT="5047" marB="0" anchor="b">
                    <a:lnL>
                      <a:noFill/>
                    </a:lnL>
                    <a:lnR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88602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843519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7B01E19-1280-0653-E360-F2AC555974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7736380"/>
              </p:ext>
            </p:extLst>
          </p:nvPr>
        </p:nvGraphicFramePr>
        <p:xfrm>
          <a:off x="0" y="1672108"/>
          <a:ext cx="7752888" cy="66971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8923443" imgH="7707889" progId="Prism9.Document">
                  <p:embed/>
                </p:oleObj>
              </mc:Choice>
              <mc:Fallback>
                <p:oleObj name="Prism 9" r:id="rId2" imgW="8923443" imgH="7707889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7B01E19-1280-0653-E360-F2AC555974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672108"/>
                        <a:ext cx="7752888" cy="66971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A407C1E-CB4A-866A-4657-71E832C83CBD}"/>
              </a:ext>
            </a:extLst>
          </p:cNvPr>
          <p:cNvSpPr txBox="1"/>
          <p:nvPr/>
        </p:nvSpPr>
        <p:spPr>
          <a:xfrm>
            <a:off x="0" y="8387530"/>
            <a:ext cx="7772400" cy="167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All taxa associated with control group based on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fSe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with plotted Log</a:t>
            </a:r>
            <a:r>
              <a:rPr lang="en-US" sz="18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linear discriminant analysis (LDA) scores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3163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8A41D6A-D0CC-2277-34C4-AF1F2FA31E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2099793"/>
              </p:ext>
            </p:extLst>
          </p:nvPr>
        </p:nvGraphicFramePr>
        <p:xfrm>
          <a:off x="-5395" y="1765300"/>
          <a:ext cx="7754108" cy="650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9191744" imgH="7707889" progId="Prism9.Document">
                  <p:embed/>
                </p:oleObj>
              </mc:Choice>
              <mc:Fallback>
                <p:oleObj name="Prism 9" r:id="rId2" imgW="9191744" imgH="7707889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8A41D6A-D0CC-2277-34C4-AF1F2FA31E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5395" y="1765300"/>
                        <a:ext cx="7754108" cy="6502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BB9F990-89BA-CDF4-CFEE-E51379A1FD04}"/>
              </a:ext>
            </a:extLst>
          </p:cNvPr>
          <p:cNvSpPr txBox="1"/>
          <p:nvPr/>
        </p:nvSpPr>
        <p:spPr>
          <a:xfrm>
            <a:off x="0" y="8400230"/>
            <a:ext cx="7772400" cy="167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All taxa associated with control group based on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fSe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with plotted Log</a:t>
            </a:r>
            <a:r>
              <a:rPr lang="en-US" sz="18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linear discriminant analysis (LDA) scores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68380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D8ED9CA-BB87-8570-6C6A-5198424708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1614339"/>
              </p:ext>
            </p:extLst>
          </p:nvPr>
        </p:nvGraphicFramePr>
        <p:xfrm>
          <a:off x="1130272" y="1754197"/>
          <a:ext cx="2501523" cy="30508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415070" imgH="2944259" progId="Prism9.Document">
                  <p:embed/>
                </p:oleObj>
              </mc:Choice>
              <mc:Fallback>
                <p:oleObj name="Prism 9" r:id="rId2" imgW="2415070" imgH="2944259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D8ED9CA-BB87-8570-6C6A-5198424708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30272" y="1754197"/>
                        <a:ext cx="2501523" cy="30508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944E460-4A1A-9DE9-1EAD-AA0D4DC53A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0554935"/>
              </p:ext>
            </p:extLst>
          </p:nvPr>
        </p:nvGraphicFramePr>
        <p:xfrm>
          <a:off x="1024497" y="5253365"/>
          <a:ext cx="2861703" cy="28386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762601" imgH="2739692" progId="Prism9.Document">
                  <p:embed/>
                </p:oleObj>
              </mc:Choice>
              <mc:Fallback>
                <p:oleObj name="Prism 9" r:id="rId4" imgW="2762601" imgH="2739692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944E460-4A1A-9DE9-1EAD-AA0D4DC53A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24497" y="5253365"/>
                        <a:ext cx="2861703" cy="28386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A2D183D-6901-16B7-B23F-7E52BB26ED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0461577"/>
              </p:ext>
            </p:extLst>
          </p:nvPr>
        </p:nvGraphicFramePr>
        <p:xfrm>
          <a:off x="3886200" y="1823273"/>
          <a:ext cx="2580467" cy="2981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491059" imgH="2878711" progId="Prism9.Document">
                  <p:embed/>
                </p:oleObj>
              </mc:Choice>
              <mc:Fallback>
                <p:oleObj name="Prism 9" r:id="rId6" imgW="2491059" imgH="2878711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A2D183D-6901-16B7-B23F-7E52BB26ED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886200" y="1823273"/>
                        <a:ext cx="2580467" cy="2981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681EFE2-69CA-FB82-A894-EF8E498860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128503"/>
              </p:ext>
            </p:extLst>
          </p:nvPr>
        </p:nvGraphicFramePr>
        <p:xfrm>
          <a:off x="3965144" y="5253364"/>
          <a:ext cx="2501523" cy="28386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415070" imgH="2739692" progId="Prism9.Document">
                  <p:embed/>
                </p:oleObj>
              </mc:Choice>
              <mc:Fallback>
                <p:oleObj name="Prism 9" r:id="rId8" imgW="2415070" imgH="273969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1681EFE2-69CA-FB82-A894-EF8E498860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965144" y="5253364"/>
                        <a:ext cx="2501523" cy="28386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85F070E6-A18D-415E-784D-5F40C328D70A}"/>
              </a:ext>
            </a:extLst>
          </p:cNvPr>
          <p:cNvSpPr txBox="1"/>
          <p:nvPr/>
        </p:nvSpPr>
        <p:spPr>
          <a:xfrm>
            <a:off x="0" y="8235130"/>
            <a:ext cx="7772400" cy="167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Boxplots of relative abundances for various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seburia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pecies. (* p &lt; 0.05, ** p &lt; 0.01, *** p &lt; 0.001; Welch t-test; Control n = 12; DSS n = 11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01869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7AE623FB-D5DA-9751-A38E-B9C194AF78BB}"/>
              </a:ext>
            </a:extLst>
          </p:cNvPr>
          <p:cNvGrpSpPr/>
          <p:nvPr/>
        </p:nvGrpSpPr>
        <p:grpSpPr>
          <a:xfrm>
            <a:off x="2084474" y="987652"/>
            <a:ext cx="3603452" cy="6433326"/>
            <a:chOff x="4114319" y="390752"/>
            <a:chExt cx="3603452" cy="6433326"/>
          </a:xfrm>
        </p:grpSpPr>
        <p:pic>
          <p:nvPicPr>
            <p:cNvPr id="4" name="Picture 3" descr="Graphical user interface&#10;&#10;Description automatically generated with medium confidence">
              <a:extLst>
                <a:ext uri="{FF2B5EF4-FFF2-40B4-BE49-F238E27FC236}">
                  <a16:creationId xmlns:a16="http://schemas.microsoft.com/office/drawing/2014/main" id="{2AC4EA1B-DF59-305C-FE44-4276C652CD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537" t="8583" r="36858" b="8296"/>
            <a:stretch/>
          </p:blipFill>
          <p:spPr>
            <a:xfrm>
              <a:off x="4114319" y="390752"/>
              <a:ext cx="3603452" cy="6433326"/>
            </a:xfrm>
            <a:prstGeom prst="rect">
              <a:avLst/>
            </a:prstGeom>
          </p:spPr>
        </p:pic>
        <p:pic>
          <p:nvPicPr>
            <p:cNvPr id="5" name="Picture 4" descr="A picture containing text, screenshot&#10;&#10;Description automatically generated">
              <a:extLst>
                <a:ext uri="{FF2B5EF4-FFF2-40B4-BE49-F238E27FC236}">
                  <a16:creationId xmlns:a16="http://schemas.microsoft.com/office/drawing/2014/main" id="{D88189CC-EA41-9DD5-BAB8-87BEF8CC2E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123" t="325" r="44888" b="98286"/>
            <a:stretch/>
          </p:blipFill>
          <p:spPr>
            <a:xfrm>
              <a:off x="5051118" y="416589"/>
              <a:ext cx="1784853" cy="227945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3C4CDB55-0C3A-160D-65C6-FE21DCA4F64C}"/>
              </a:ext>
            </a:extLst>
          </p:cNvPr>
          <p:cNvSpPr txBox="1"/>
          <p:nvPr/>
        </p:nvSpPr>
        <p:spPr>
          <a:xfrm>
            <a:off x="0" y="7607333"/>
            <a:ext cx="7772400" cy="22289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: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map of differentially altered mucosal metabolites between control and DSS treated mice (p &lt; 0.05, q &lt; 0.1, Welch t-test). Heatmap was scaled from -4 to 4. (Control = 6; DSS n = 7). + indicated DSS treatment, - indicates control group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47331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41CA2F0-9E6C-4B60-6A25-E894FE8330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7415245"/>
              </p:ext>
            </p:extLst>
          </p:nvPr>
        </p:nvGraphicFramePr>
        <p:xfrm>
          <a:off x="385647" y="1108078"/>
          <a:ext cx="1936512" cy="15054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850931" imgH="2994321" progId="Prism9.Document">
                  <p:embed/>
                </p:oleObj>
              </mc:Choice>
              <mc:Fallback>
                <p:oleObj name="Prism 9" r:id="rId2" imgW="3850931" imgH="2994321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41CA2F0-9E6C-4B60-6A25-E894FE8330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5647" y="1108078"/>
                        <a:ext cx="1936512" cy="15054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45E9B9E-F7F0-B8BB-B426-6C8669160E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8156490"/>
              </p:ext>
            </p:extLst>
          </p:nvPr>
        </p:nvGraphicFramePr>
        <p:xfrm>
          <a:off x="5362202" y="4891016"/>
          <a:ext cx="1875846" cy="15054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730646" imgH="2994321" progId="Prism9.Document">
                  <p:embed/>
                </p:oleObj>
              </mc:Choice>
              <mc:Fallback>
                <p:oleObj name="Prism 9" r:id="rId4" imgW="3730646" imgH="2994321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45E9B9E-F7F0-B8BB-B426-6C8669160E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62202" y="4891016"/>
                        <a:ext cx="1875846" cy="15054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CDAB74F-C2AC-74CA-14A1-0CA7055506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9417266"/>
              </p:ext>
            </p:extLst>
          </p:nvPr>
        </p:nvGraphicFramePr>
        <p:xfrm>
          <a:off x="2874723" y="1134652"/>
          <a:ext cx="1934915" cy="15054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848050" imgH="2994321" progId="Prism9.Document">
                  <p:embed/>
                </p:oleObj>
              </mc:Choice>
              <mc:Fallback>
                <p:oleObj name="Prism 9" r:id="rId6" imgW="3848050" imgH="2994321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1CDAB74F-C2AC-74CA-14A1-0CA7055506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874723" y="1134652"/>
                        <a:ext cx="1934915" cy="15054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A1E7550-C7C2-2BD0-60B1-5BEFDC7982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0017193"/>
              </p:ext>
            </p:extLst>
          </p:nvPr>
        </p:nvGraphicFramePr>
        <p:xfrm>
          <a:off x="5362202" y="1134652"/>
          <a:ext cx="1933318" cy="15054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844809" imgH="2994321" progId="Prism9.Document">
                  <p:embed/>
                </p:oleObj>
              </mc:Choice>
              <mc:Fallback>
                <p:oleObj name="Prism 9" r:id="rId8" imgW="3844809" imgH="2994321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DA1E7550-C7C2-2BD0-60B1-5BEFDC7982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362202" y="1134652"/>
                        <a:ext cx="1933318" cy="15054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D0F0494-396F-A669-C444-BB92767887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2509390"/>
              </p:ext>
            </p:extLst>
          </p:nvPr>
        </p:nvGraphicFramePr>
        <p:xfrm>
          <a:off x="532704" y="3155330"/>
          <a:ext cx="1898996" cy="1275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776383" imgH="2536925" progId="Prism9.Document">
                  <p:embed/>
                </p:oleObj>
              </mc:Choice>
              <mc:Fallback>
                <p:oleObj name="Prism 9" r:id="rId10" imgW="3776383" imgH="2536925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DD0F0494-396F-A669-C444-BB92767887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32704" y="3155330"/>
                        <a:ext cx="1898996" cy="1275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3F00A8F-1A1D-7DB9-74E7-28E23B958E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773359"/>
              </p:ext>
            </p:extLst>
          </p:nvPr>
        </p:nvGraphicFramePr>
        <p:xfrm>
          <a:off x="2796708" y="4898609"/>
          <a:ext cx="1933318" cy="15054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844809" imgH="2994321" progId="Prism9.Document">
                  <p:embed/>
                </p:oleObj>
              </mc:Choice>
              <mc:Fallback>
                <p:oleObj name="Prism 9" r:id="rId12" imgW="3844809" imgH="2994321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3F00A8F-1A1D-7DB9-74E7-28E23B958E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796708" y="4898609"/>
                        <a:ext cx="1933318" cy="15054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B221EF29-24DD-7F2D-BBCB-5A195F7D46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3418011"/>
              </p:ext>
            </p:extLst>
          </p:nvPr>
        </p:nvGraphicFramePr>
        <p:xfrm>
          <a:off x="2865323" y="3155330"/>
          <a:ext cx="1870260" cy="15054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3719842" imgH="2994321" progId="Prism9.Document">
                  <p:embed/>
                </p:oleObj>
              </mc:Choice>
              <mc:Fallback>
                <p:oleObj name="Prism 9" r:id="rId14" imgW="3719842" imgH="2994321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B221EF29-24DD-7F2D-BBCB-5A195F7D46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865323" y="3155330"/>
                        <a:ext cx="1870260" cy="15054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03954A56-399A-C171-F87E-461B6FF947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2996708"/>
              </p:ext>
            </p:extLst>
          </p:nvPr>
        </p:nvGraphicFramePr>
        <p:xfrm>
          <a:off x="5341448" y="3294208"/>
          <a:ext cx="1896600" cy="12755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3771701" imgH="2536925" progId="Prism9.Document">
                  <p:embed/>
                </p:oleObj>
              </mc:Choice>
              <mc:Fallback>
                <p:oleObj name="Prism 9" r:id="rId16" imgW="3771701" imgH="2536925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03954A56-399A-C171-F87E-461B6FF947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341448" y="3294208"/>
                        <a:ext cx="1896600" cy="12755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ADEFF720-5FA2-13CA-3297-002889D03F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0835957"/>
              </p:ext>
            </p:extLst>
          </p:nvPr>
        </p:nvGraphicFramePr>
        <p:xfrm>
          <a:off x="5826382" y="6665147"/>
          <a:ext cx="1933318" cy="12388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3844809" imgH="2463814" progId="Prism9.Document">
                  <p:embed/>
                </p:oleObj>
              </mc:Choice>
              <mc:Fallback>
                <p:oleObj name="Prism 9" r:id="rId18" imgW="3844809" imgH="2463814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ADEFF720-5FA2-13CA-3297-002889D03F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826382" y="6665147"/>
                        <a:ext cx="1933318" cy="12388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53B1CE66-5E20-BBF7-B8BE-8D4462EFAE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8996637"/>
              </p:ext>
            </p:extLst>
          </p:nvPr>
        </p:nvGraphicFramePr>
        <p:xfrm>
          <a:off x="-5485" y="6723194"/>
          <a:ext cx="1893408" cy="13242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0" imgW="3765579" imgH="2633086" progId="Prism9.Document">
                  <p:embed/>
                </p:oleObj>
              </mc:Choice>
              <mc:Fallback>
                <p:oleObj name="Prism 9" r:id="rId20" imgW="3765579" imgH="2633086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53B1CE66-5E20-BBF7-B8BE-8D4462EFAE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-5485" y="6723194"/>
                        <a:ext cx="1893408" cy="13242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5DF76DF1-4F22-C165-52ED-20A3644D7D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8233852"/>
              </p:ext>
            </p:extLst>
          </p:nvPr>
        </p:nvGraphicFramePr>
        <p:xfrm>
          <a:off x="1933724" y="6730427"/>
          <a:ext cx="1952476" cy="13553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2" imgW="3882983" imgH="2695753" progId="Prism9.Document">
                  <p:embed/>
                </p:oleObj>
              </mc:Choice>
              <mc:Fallback>
                <p:oleObj name="Prism 9" r:id="rId22" imgW="3882983" imgH="2695753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5DF76DF1-4F22-C165-52ED-20A3644D7D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1933724" y="6730427"/>
                        <a:ext cx="1952476" cy="13553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EB32D0B8-6328-E5F9-DB50-6970C90DB8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7896343"/>
              </p:ext>
            </p:extLst>
          </p:nvPr>
        </p:nvGraphicFramePr>
        <p:xfrm>
          <a:off x="3932001" y="6765477"/>
          <a:ext cx="1909373" cy="12388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4" imgW="3797631" imgH="2463814" progId="Prism9.Document">
                  <p:embed/>
                </p:oleObj>
              </mc:Choice>
              <mc:Fallback>
                <p:oleObj name="Prism 9" r:id="rId24" imgW="3797631" imgH="2463814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EB32D0B8-6328-E5F9-DB50-6970C90DB8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3932001" y="6765477"/>
                        <a:ext cx="1909373" cy="12388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07258807-F5F4-30FA-0757-0C2E85AAAB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0577337"/>
              </p:ext>
            </p:extLst>
          </p:nvPr>
        </p:nvGraphicFramePr>
        <p:xfrm>
          <a:off x="503171" y="4913066"/>
          <a:ext cx="1928529" cy="15054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6" imgW="3835805" imgH="2994321" progId="Prism9.Document">
                  <p:embed/>
                </p:oleObj>
              </mc:Choice>
              <mc:Fallback>
                <p:oleObj name="Prism 9" r:id="rId26" imgW="3835805" imgH="2994321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07258807-F5F4-30FA-0757-0C2E85AAAB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503171" y="4913066"/>
                        <a:ext cx="1928529" cy="15054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041CBC0A-776A-B9A7-BFCF-9D45200B8925}"/>
              </a:ext>
            </a:extLst>
          </p:cNvPr>
          <p:cNvSpPr txBox="1"/>
          <p:nvPr/>
        </p:nvSpPr>
        <p:spPr>
          <a:xfrm>
            <a:off x="-5485" y="8214532"/>
            <a:ext cx="7765185" cy="167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6: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rrelation plots showing linear regression models between microbial related metabolites and MPO activity with significant Spearman correlation coefficients. (* p &lt; 0.05, ** p &lt; 0.01)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14248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iagram, schematic&#10;&#10;Description automatically generated">
            <a:extLst>
              <a:ext uri="{FF2B5EF4-FFF2-40B4-BE49-F238E27FC236}">
                <a16:creationId xmlns:a16="http://schemas.microsoft.com/office/drawing/2014/main" id="{E808A07A-D3E1-D6E3-8737-771FB9C11B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0054" y="751519"/>
            <a:ext cx="4592292" cy="657416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D9BABB2-33AE-6102-7885-CBCB4E70D5EE}"/>
              </a:ext>
            </a:extLst>
          </p:cNvPr>
          <p:cNvSpPr txBox="1"/>
          <p:nvPr/>
        </p:nvSpPr>
        <p:spPr>
          <a:xfrm>
            <a:off x="0" y="8382727"/>
            <a:ext cx="7772400" cy="167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7: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hview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ndering of alterations in glycolysis/gluconeogenesis. Purple indicates an increase in chronic colitis and yellow indicates a decreas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93728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gram, schematic&#10;&#10;Description automatically generated">
            <a:extLst>
              <a:ext uri="{FF2B5EF4-FFF2-40B4-BE49-F238E27FC236}">
                <a16:creationId xmlns:a16="http://schemas.microsoft.com/office/drawing/2014/main" id="{E8DF244C-20D1-258D-4662-3E89B1C10B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497" y="1756"/>
            <a:ext cx="6131405" cy="4241207"/>
          </a:xfrm>
          <a:prstGeom prst="rect">
            <a:avLst/>
          </a:prstGeom>
        </p:spPr>
      </p:pic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E92F7755-5825-B60E-FA00-232956BCA8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356" y="4466781"/>
            <a:ext cx="6131406" cy="378967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E39634C-06CE-0733-7427-96EDA7AED40C}"/>
              </a:ext>
            </a:extLst>
          </p:cNvPr>
          <p:cNvSpPr txBox="1"/>
          <p:nvPr/>
        </p:nvSpPr>
        <p:spPr>
          <a:xfrm>
            <a:off x="-7141" y="8383454"/>
            <a:ext cx="7772400" cy="167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8: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hview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nderings of alterations in pyrimidine and purine metabolism. Purple indicates an increase in chronic colitis and yellow indicates a decreas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28163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312731CB-6499-566B-F802-4B4EDF7142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1663" y="4785019"/>
            <a:ext cx="3030436" cy="2734328"/>
          </a:xfrm>
          <a:prstGeom prst="rect">
            <a:avLst/>
          </a:prstGeom>
        </p:spPr>
      </p:pic>
      <p:pic>
        <p:nvPicPr>
          <p:cNvPr id="9" name="Picture 8" descr="Diagram, schematic&#10;&#10;Description automatically generated">
            <a:extLst>
              <a:ext uri="{FF2B5EF4-FFF2-40B4-BE49-F238E27FC236}">
                <a16:creationId xmlns:a16="http://schemas.microsoft.com/office/drawing/2014/main" id="{409D85BE-53D2-09AA-7523-B64FFB2B85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627" y="4998671"/>
            <a:ext cx="4010717" cy="2273165"/>
          </a:xfrm>
          <a:prstGeom prst="rect">
            <a:avLst/>
          </a:prstGeom>
        </p:spPr>
      </p:pic>
      <p:pic>
        <p:nvPicPr>
          <p:cNvPr id="11" name="Picture 10" descr="Diagram, schematic&#10;&#10;Description automatically generated">
            <a:extLst>
              <a:ext uri="{FF2B5EF4-FFF2-40B4-BE49-F238E27FC236}">
                <a16:creationId xmlns:a16="http://schemas.microsoft.com/office/drawing/2014/main" id="{78DB7A54-FA13-27B8-0531-839E3E4D2E7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203" y="1472632"/>
            <a:ext cx="2967563" cy="2737171"/>
          </a:xfrm>
          <a:prstGeom prst="rect">
            <a:avLst/>
          </a:prstGeom>
        </p:spPr>
      </p:pic>
      <p:pic>
        <p:nvPicPr>
          <p:cNvPr id="7" name="Picture 6" descr="Diagram, schematic&#10;&#10;Description automatically generated">
            <a:extLst>
              <a:ext uri="{FF2B5EF4-FFF2-40B4-BE49-F238E27FC236}">
                <a16:creationId xmlns:a16="http://schemas.microsoft.com/office/drawing/2014/main" id="{26269824-269D-07B0-5168-9432A3F54B7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1663" y="1464453"/>
            <a:ext cx="2932474" cy="274535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15205C1-C2EF-26EE-5084-0A6B4E9940B8}"/>
              </a:ext>
            </a:extLst>
          </p:cNvPr>
          <p:cNvSpPr txBox="1"/>
          <p:nvPr/>
        </p:nvSpPr>
        <p:spPr>
          <a:xfrm>
            <a:off x="0" y="7800961"/>
            <a:ext cx="7772400" cy="22289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9: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hview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nderings of alterations in alanine aspartate and glutamate metabolism; histidine metabolism; tryptophan metabolism; and glycine, serine and threonine metabolism.  Purple indicates an increase in chronic colitis and yellow indicates a decreas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0838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59</TotalTime>
  <Words>590</Words>
  <Application>Microsoft Office PowerPoint</Application>
  <PresentationFormat>Custom</PresentationFormat>
  <Paragraphs>156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lzadilla, Nathan</dc:creator>
  <cp:lastModifiedBy>Calzadilla, Nathan</cp:lastModifiedBy>
  <cp:revision>17</cp:revision>
  <dcterms:created xsi:type="dcterms:W3CDTF">2023-06-08T19:38:07Z</dcterms:created>
  <dcterms:modified xsi:type="dcterms:W3CDTF">2023-07-23T01:11:41Z</dcterms:modified>
</cp:coreProperties>
</file>